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140030F-7F71-45D2-8A31-C46EBA9DB34A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5" name="Rectangle 7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DF23501-4C99-4AE8-AD7A-C1AA1EB755F0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6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127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2416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txBody>
          <a:bodyPr lIns="4680" rIns="4680" tIns="4680" bIns="468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BCBFFF-6A3D-40DD-A4C2-12B84E37643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9DFF6B-851D-4DB8-8970-396370F98F7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9E71F3-3567-4478-B04D-BE786756D0F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C4F0CD-4CB6-4494-A89E-79AB545FA48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1E7666-2A7A-4862-B78A-F8ECBBEA458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C23577F-DDAD-4E2D-BFC3-923B4186862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B1F63F-8C42-4ED8-AC5B-FF97768C451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8EB482-49D7-4255-8699-041A0D6CF12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1A6608-0FD3-4E4D-B9FB-A1918CDCEB1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EB65F4-378E-4E35-A1EB-7AC1D50C6C0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9EFEFF-F0A0-4ED7-B46A-0A5967B3FAE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3685DF-1381-4AE3-A41D-46E250B92B1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F4081CD-A277-408C-AE64-00D1B59BCB63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8" name="Group 8"/>
          <p:cNvGrpSpPr/>
          <p:nvPr/>
        </p:nvGrpSpPr>
        <p:grpSpPr>
          <a:xfrm>
            <a:off x="76320" y="2666880"/>
            <a:ext cx="9004320" cy="2121120"/>
            <a:chOff x="76320" y="2666880"/>
            <a:chExt cx="9004320" cy="2121120"/>
          </a:xfrm>
        </p:grpSpPr>
        <p:sp>
          <p:nvSpPr>
            <p:cNvPr id="49" name="AutoShape 7"/>
            <p:cNvSpPr/>
            <p:nvPr/>
          </p:nvSpPr>
          <p:spPr>
            <a:xfrm>
              <a:off x="76320" y="2666880"/>
              <a:ext cx="9004320" cy="2121120"/>
            </a:xfrm>
            <a:prstGeom prst="rect">
              <a:avLst/>
            </a:prstGeom>
            <a:solidFill>
              <a:srgbClr val="bbe0e3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0" name="Rectangle 9"/>
            <p:cNvSpPr/>
            <p:nvPr/>
          </p:nvSpPr>
          <p:spPr>
            <a:xfrm>
              <a:off x="79200" y="2670120"/>
              <a:ext cx="8999640" cy="32724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" name="Rectangle 10"/>
            <p:cNvSpPr/>
            <p:nvPr/>
          </p:nvSpPr>
          <p:spPr>
            <a:xfrm>
              <a:off x="1099440" y="2757600"/>
              <a:ext cx="1353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MIPS Functional Category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" name="Rectangle 11"/>
            <p:cNvSpPr/>
            <p:nvPr/>
          </p:nvSpPr>
          <p:spPr>
            <a:xfrm>
              <a:off x="3511080" y="2757600"/>
              <a:ext cx="3924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p-value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" name="Rectangle 12"/>
            <p:cNvSpPr/>
            <p:nvPr/>
          </p:nvSpPr>
          <p:spPr>
            <a:xfrm>
              <a:off x="4673880" y="2757600"/>
              <a:ext cx="12884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In Category from Cluster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" name="Rectangle 13"/>
            <p:cNvSpPr/>
            <p:nvPr/>
          </p:nvSpPr>
          <p:spPr>
            <a:xfrm>
              <a:off x="6736680" y="2676600"/>
              <a:ext cx="9090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# Nickel  Toxicity 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" name="Rectangle 14"/>
            <p:cNvSpPr/>
            <p:nvPr/>
          </p:nvSpPr>
          <p:spPr>
            <a:xfrm>
              <a:off x="6856920" y="2840040"/>
              <a:ext cx="6134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Modulating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" name="Rectangle 15"/>
            <p:cNvSpPr/>
            <p:nvPr/>
          </p:nvSpPr>
          <p:spPr>
            <a:xfrm>
              <a:off x="8040600" y="2757600"/>
              <a:ext cx="896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Total in Category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" name="Rectangle 16"/>
            <p:cNvSpPr/>
            <p:nvPr/>
          </p:nvSpPr>
          <p:spPr>
            <a:xfrm>
              <a:off x="817560" y="3086280"/>
              <a:ext cx="19238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homeostasis of protons [34.01.01.03]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" name="Rectangle 17"/>
            <p:cNvSpPr/>
            <p:nvPr/>
          </p:nvSpPr>
          <p:spPr>
            <a:xfrm>
              <a:off x="3436920" y="3086280"/>
              <a:ext cx="5446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0.0001148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" name="Rectangle 18"/>
            <p:cNvSpPr/>
            <p:nvPr/>
          </p:nvSpPr>
          <p:spPr>
            <a:xfrm>
              <a:off x="4410360" y="3086280"/>
              <a:ext cx="18691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VMA2 CUP5 RAV1 VMA6 STV1 VPH1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0" name="Rectangle 19"/>
            <p:cNvSpPr/>
            <p:nvPr/>
          </p:nvSpPr>
          <p:spPr>
            <a:xfrm>
              <a:off x="7108200" y="3086280"/>
              <a:ext cx="648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6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1" name="Rectangle 20"/>
            <p:cNvSpPr/>
            <p:nvPr/>
          </p:nvSpPr>
          <p:spPr>
            <a:xfrm>
              <a:off x="8393040" y="3086280"/>
              <a:ext cx="1288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47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2" name="Rectangle 21"/>
            <p:cNvSpPr/>
            <p:nvPr/>
          </p:nvSpPr>
          <p:spPr>
            <a:xfrm>
              <a:off x="567000" y="3335400"/>
              <a:ext cx="25092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cation transport (H+, Na+, K+, Ca2+ , NH4+, etc.) 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3" name="Rectangle 22"/>
            <p:cNvSpPr/>
            <p:nvPr/>
          </p:nvSpPr>
          <p:spPr>
            <a:xfrm>
              <a:off x="1398960" y="3490920"/>
              <a:ext cx="685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[20.01.01.01]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4" name="Rectangle 23"/>
            <p:cNvSpPr/>
            <p:nvPr/>
          </p:nvSpPr>
          <p:spPr>
            <a:xfrm>
              <a:off x="3436920" y="3411360"/>
              <a:ext cx="5446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0.0008821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5" name="Rectangle 24"/>
            <p:cNvSpPr/>
            <p:nvPr/>
          </p:nvSpPr>
          <p:spPr>
            <a:xfrm>
              <a:off x="4412880" y="3411360"/>
              <a:ext cx="1866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VMA2 CUP5 TOK1 VMA6 STV1 VPH1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6" name="Rectangle 25"/>
            <p:cNvSpPr/>
            <p:nvPr/>
          </p:nvSpPr>
          <p:spPr>
            <a:xfrm>
              <a:off x="7108200" y="3411360"/>
              <a:ext cx="648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6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7" name="Rectangle 26"/>
            <p:cNvSpPr/>
            <p:nvPr/>
          </p:nvSpPr>
          <p:spPr>
            <a:xfrm>
              <a:off x="8393040" y="3411360"/>
              <a:ext cx="1288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68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8" name="Rectangle 27"/>
            <p:cNvSpPr/>
            <p:nvPr/>
          </p:nvSpPr>
          <p:spPr>
            <a:xfrm>
              <a:off x="1026000" y="3656160"/>
              <a:ext cx="1488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transport ATPases [20.03.22]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9" name="Rectangle 28"/>
            <p:cNvSpPr/>
            <p:nvPr/>
          </p:nvSpPr>
          <p:spPr>
            <a:xfrm>
              <a:off x="3465360" y="3656160"/>
              <a:ext cx="48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0.001779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0" name="Rectangle 29"/>
            <p:cNvSpPr/>
            <p:nvPr/>
          </p:nvSpPr>
          <p:spPr>
            <a:xfrm>
              <a:off x="4551120" y="3656160"/>
              <a:ext cx="1562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VMA2 CUP5 VMA6 STV1 VPH1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1" name="Rectangle 30"/>
            <p:cNvSpPr/>
            <p:nvPr/>
          </p:nvSpPr>
          <p:spPr>
            <a:xfrm>
              <a:off x="7108200" y="3656160"/>
              <a:ext cx="648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5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2" name="Rectangle 31"/>
            <p:cNvSpPr/>
            <p:nvPr/>
          </p:nvSpPr>
          <p:spPr>
            <a:xfrm>
              <a:off x="8393040" y="3656160"/>
              <a:ext cx="1288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53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3" name="Rectangle 32"/>
            <p:cNvSpPr/>
            <p:nvPr/>
          </p:nvSpPr>
          <p:spPr>
            <a:xfrm>
              <a:off x="753120" y="3898800"/>
              <a:ext cx="2064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vacuolar/lysosomal transport [20.09.13]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4" name="Rectangle 33"/>
            <p:cNvSpPr/>
            <p:nvPr/>
          </p:nvSpPr>
          <p:spPr>
            <a:xfrm>
              <a:off x="3465360" y="3898800"/>
              <a:ext cx="48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0.003849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5" name="Rectangle 34"/>
            <p:cNvSpPr/>
            <p:nvPr/>
          </p:nvSpPr>
          <p:spPr>
            <a:xfrm>
              <a:off x="4598280" y="3822840"/>
              <a:ext cx="12916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VMA2 CUP5 FAB1 VMA6 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6" name="Rectangle 35"/>
            <p:cNvSpPr/>
            <p:nvPr/>
          </p:nvSpPr>
          <p:spPr>
            <a:xfrm>
              <a:off x="5010480" y="3978360"/>
              <a:ext cx="5644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STV1 VPH1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7" name="Rectangle 36"/>
            <p:cNvSpPr/>
            <p:nvPr/>
          </p:nvSpPr>
          <p:spPr>
            <a:xfrm>
              <a:off x="7073280" y="3898800"/>
              <a:ext cx="648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6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8" name="Rectangle 37"/>
            <p:cNvSpPr/>
            <p:nvPr/>
          </p:nvSpPr>
          <p:spPr>
            <a:xfrm>
              <a:off x="8363520" y="3898800"/>
              <a:ext cx="192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153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9" name="Rectangle 38"/>
            <p:cNvSpPr/>
            <p:nvPr/>
          </p:nvSpPr>
          <p:spPr>
            <a:xfrm>
              <a:off x="502920" y="4148280"/>
              <a:ext cx="26038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metabolism of secondary products derived from L-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0" name="Rectangle 39"/>
            <p:cNvSpPr/>
            <p:nvPr/>
          </p:nvSpPr>
          <p:spPr>
            <a:xfrm>
              <a:off x="688320" y="4303800"/>
              <a:ext cx="22042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lysine, L-arginine and L-histidine [01.20.31]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1" name="Rectangle 40"/>
            <p:cNvSpPr/>
            <p:nvPr/>
          </p:nvSpPr>
          <p:spPr>
            <a:xfrm>
              <a:off x="3465360" y="4224240"/>
              <a:ext cx="48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0.003949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2" name="Rectangle 41"/>
            <p:cNvSpPr/>
            <p:nvPr/>
          </p:nvSpPr>
          <p:spPr>
            <a:xfrm>
              <a:off x="5038200" y="4224240"/>
              <a:ext cx="498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JJJ3 DPH2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3" name="Rectangle 42"/>
            <p:cNvSpPr/>
            <p:nvPr/>
          </p:nvSpPr>
          <p:spPr>
            <a:xfrm>
              <a:off x="7108200" y="4224240"/>
              <a:ext cx="648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2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4" name="Rectangle 43"/>
            <p:cNvSpPr/>
            <p:nvPr/>
          </p:nvSpPr>
          <p:spPr>
            <a:xfrm>
              <a:off x="8422560" y="4224240"/>
              <a:ext cx="648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6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5" name="Rectangle 44"/>
            <p:cNvSpPr/>
            <p:nvPr/>
          </p:nvSpPr>
          <p:spPr>
            <a:xfrm>
              <a:off x="1015200" y="4470480"/>
              <a:ext cx="15048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cell cycle arrest [10.03.01.02]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6" name="Rectangle 45"/>
            <p:cNvSpPr/>
            <p:nvPr/>
          </p:nvSpPr>
          <p:spPr>
            <a:xfrm>
              <a:off x="3465360" y="4470480"/>
              <a:ext cx="48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0.004809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7" name="Rectangle 46"/>
            <p:cNvSpPr/>
            <p:nvPr/>
          </p:nvSpPr>
          <p:spPr>
            <a:xfrm>
              <a:off x="4856760" y="4470480"/>
              <a:ext cx="8938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PIN4 FAR7 FAR1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8" name="Rectangle 47"/>
            <p:cNvSpPr/>
            <p:nvPr/>
          </p:nvSpPr>
          <p:spPr>
            <a:xfrm>
              <a:off x="7108200" y="4470480"/>
              <a:ext cx="648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3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9" name="Rectangle 48"/>
            <p:cNvSpPr/>
            <p:nvPr/>
          </p:nvSpPr>
          <p:spPr>
            <a:xfrm>
              <a:off x="8393040" y="4470480"/>
              <a:ext cx="1288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21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0" name="Rectangle 49"/>
            <p:cNvSpPr/>
            <p:nvPr/>
          </p:nvSpPr>
          <p:spPr>
            <a:xfrm>
              <a:off x="911880" y="4632480"/>
              <a:ext cx="1731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DNA recombination [10.01.05.03]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1" name="Rectangle 50"/>
            <p:cNvSpPr/>
            <p:nvPr/>
          </p:nvSpPr>
          <p:spPr>
            <a:xfrm>
              <a:off x="3465360" y="4632480"/>
              <a:ext cx="48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0.009838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2" name="Rectangle 51"/>
            <p:cNvSpPr/>
            <p:nvPr/>
          </p:nvSpPr>
          <p:spPr>
            <a:xfrm>
              <a:off x="4853880" y="4632480"/>
              <a:ext cx="9014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FOB1 HPR1 MFT1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3" name="Rectangle 52"/>
            <p:cNvSpPr/>
            <p:nvPr/>
          </p:nvSpPr>
          <p:spPr>
            <a:xfrm>
              <a:off x="7108200" y="4632480"/>
              <a:ext cx="648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3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4" name="Rectangle 53"/>
            <p:cNvSpPr/>
            <p:nvPr/>
          </p:nvSpPr>
          <p:spPr>
            <a:xfrm>
              <a:off x="8393040" y="4632480"/>
              <a:ext cx="1288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27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5" name="Line 54"/>
            <p:cNvSpPr/>
            <p:nvPr/>
          </p:nvSpPr>
          <p:spPr>
            <a:xfrm>
              <a:off x="76320" y="2666880"/>
              <a:ext cx="1440" cy="2121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6" name="Rectangle 55"/>
            <p:cNvSpPr/>
            <p:nvPr/>
          </p:nvSpPr>
          <p:spPr>
            <a:xfrm>
              <a:off x="76320" y="2666880"/>
              <a:ext cx="6120" cy="21211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7" name="Line 56"/>
            <p:cNvSpPr/>
            <p:nvPr/>
          </p:nvSpPr>
          <p:spPr>
            <a:xfrm>
              <a:off x="3292560" y="2673360"/>
              <a:ext cx="1440" cy="21146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8" name="Rectangle 57"/>
            <p:cNvSpPr/>
            <p:nvPr/>
          </p:nvSpPr>
          <p:spPr>
            <a:xfrm>
              <a:off x="3292560" y="2673360"/>
              <a:ext cx="6120" cy="211464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9" name="Line 58"/>
            <p:cNvSpPr/>
            <p:nvPr/>
          </p:nvSpPr>
          <p:spPr>
            <a:xfrm>
              <a:off x="4014720" y="2673360"/>
              <a:ext cx="1800" cy="21146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0" name="Rectangle 59"/>
            <p:cNvSpPr/>
            <p:nvPr/>
          </p:nvSpPr>
          <p:spPr>
            <a:xfrm>
              <a:off x="4014720" y="2673360"/>
              <a:ext cx="7920" cy="211464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1" name="Line 60"/>
            <p:cNvSpPr/>
            <p:nvPr/>
          </p:nvSpPr>
          <p:spPr>
            <a:xfrm>
              <a:off x="6445080" y="2673360"/>
              <a:ext cx="1800" cy="21146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2" name="Rectangle 61"/>
            <p:cNvSpPr/>
            <p:nvPr/>
          </p:nvSpPr>
          <p:spPr>
            <a:xfrm>
              <a:off x="6445080" y="2673360"/>
              <a:ext cx="6480" cy="211464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3" name="Line 62"/>
            <p:cNvSpPr/>
            <p:nvPr/>
          </p:nvSpPr>
          <p:spPr>
            <a:xfrm>
              <a:off x="7759800" y="2673360"/>
              <a:ext cx="1440" cy="21146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4" name="Rectangle 63"/>
            <p:cNvSpPr/>
            <p:nvPr/>
          </p:nvSpPr>
          <p:spPr>
            <a:xfrm>
              <a:off x="7759800" y="2673360"/>
              <a:ext cx="6120" cy="211464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5" name="Line 64"/>
            <p:cNvSpPr/>
            <p:nvPr/>
          </p:nvSpPr>
          <p:spPr>
            <a:xfrm>
              <a:off x="9074160" y="2673360"/>
              <a:ext cx="1440" cy="21146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6" name="Rectangle 65"/>
            <p:cNvSpPr/>
            <p:nvPr/>
          </p:nvSpPr>
          <p:spPr>
            <a:xfrm>
              <a:off x="9074160" y="2673360"/>
              <a:ext cx="6480" cy="211464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7" name="Line 66"/>
            <p:cNvSpPr/>
            <p:nvPr/>
          </p:nvSpPr>
          <p:spPr>
            <a:xfrm>
              <a:off x="82440" y="2666880"/>
              <a:ext cx="899820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8" name="Rectangle 67"/>
            <p:cNvSpPr/>
            <p:nvPr/>
          </p:nvSpPr>
          <p:spPr>
            <a:xfrm>
              <a:off x="82440" y="2666880"/>
              <a:ext cx="8998200" cy="64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320" bIns="-40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9" name="Line 68"/>
            <p:cNvSpPr/>
            <p:nvPr/>
          </p:nvSpPr>
          <p:spPr>
            <a:xfrm>
              <a:off x="82440" y="2992320"/>
              <a:ext cx="899820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0" name="Rectangle 69"/>
            <p:cNvSpPr/>
            <p:nvPr/>
          </p:nvSpPr>
          <p:spPr>
            <a:xfrm>
              <a:off x="82440" y="2992320"/>
              <a:ext cx="8998200" cy="64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320" bIns="-40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1" name="Line 70"/>
            <p:cNvSpPr/>
            <p:nvPr/>
          </p:nvSpPr>
          <p:spPr>
            <a:xfrm>
              <a:off x="82440" y="3317760"/>
              <a:ext cx="899820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2" name="Rectangle 71"/>
            <p:cNvSpPr/>
            <p:nvPr/>
          </p:nvSpPr>
          <p:spPr>
            <a:xfrm>
              <a:off x="82440" y="3317760"/>
              <a:ext cx="8998200" cy="64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320" bIns="-40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3" name="Line 72"/>
            <p:cNvSpPr/>
            <p:nvPr/>
          </p:nvSpPr>
          <p:spPr>
            <a:xfrm>
              <a:off x="82440" y="3643200"/>
              <a:ext cx="899820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4" name="Rectangle 73"/>
            <p:cNvSpPr/>
            <p:nvPr/>
          </p:nvSpPr>
          <p:spPr>
            <a:xfrm>
              <a:off x="82440" y="3643200"/>
              <a:ext cx="8998200" cy="64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320" bIns="-40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5" name="Line 74"/>
            <p:cNvSpPr/>
            <p:nvPr/>
          </p:nvSpPr>
          <p:spPr>
            <a:xfrm>
              <a:off x="82440" y="3805200"/>
              <a:ext cx="899820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6" name="Rectangle 75"/>
            <p:cNvSpPr/>
            <p:nvPr/>
          </p:nvSpPr>
          <p:spPr>
            <a:xfrm>
              <a:off x="82440" y="3805200"/>
              <a:ext cx="8998200" cy="64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320" bIns="-40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7" name="Line 76"/>
            <p:cNvSpPr/>
            <p:nvPr/>
          </p:nvSpPr>
          <p:spPr>
            <a:xfrm>
              <a:off x="82440" y="4130640"/>
              <a:ext cx="899820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8" name="Rectangle 77"/>
            <p:cNvSpPr/>
            <p:nvPr/>
          </p:nvSpPr>
          <p:spPr>
            <a:xfrm>
              <a:off x="82440" y="4130640"/>
              <a:ext cx="8998200" cy="64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320" bIns="-40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9" name="Line 78"/>
            <p:cNvSpPr/>
            <p:nvPr/>
          </p:nvSpPr>
          <p:spPr>
            <a:xfrm>
              <a:off x="82440" y="4456080"/>
              <a:ext cx="899820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0" name="Rectangle 79"/>
            <p:cNvSpPr/>
            <p:nvPr/>
          </p:nvSpPr>
          <p:spPr>
            <a:xfrm>
              <a:off x="82440" y="4456080"/>
              <a:ext cx="8998200" cy="64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320" bIns="-40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1" name="Line 80"/>
            <p:cNvSpPr/>
            <p:nvPr/>
          </p:nvSpPr>
          <p:spPr>
            <a:xfrm>
              <a:off x="82440" y="4618080"/>
              <a:ext cx="899820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2" name="Rectangle 81"/>
            <p:cNvSpPr/>
            <p:nvPr/>
          </p:nvSpPr>
          <p:spPr>
            <a:xfrm>
              <a:off x="82440" y="4618080"/>
              <a:ext cx="8998200" cy="79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3" name="Line 82"/>
            <p:cNvSpPr/>
            <p:nvPr/>
          </p:nvSpPr>
          <p:spPr>
            <a:xfrm>
              <a:off x="82440" y="4781520"/>
              <a:ext cx="899820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4" name="Rectangle 83"/>
            <p:cNvSpPr/>
            <p:nvPr/>
          </p:nvSpPr>
          <p:spPr>
            <a:xfrm>
              <a:off x="82440" y="4781520"/>
              <a:ext cx="8998200" cy="64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320" bIns="-40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6-18T22:22:44Z</dcterms:created>
  <dc:creator>Administrator</dc:creator>
  <dc:description/>
  <dc:language>en-US</dc:language>
  <cp:lastModifiedBy>Administrator</cp:lastModifiedBy>
  <dcterms:modified xsi:type="dcterms:W3CDTF">2009-06-18T22:23:26Z</dcterms:modified>
  <cp:revision>1</cp:revision>
  <dc:subject/>
  <dc:title>Slide 1</dc:title>
</cp:coreProperties>
</file>